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10"/>
  </p:notesMasterIdLst>
  <p:sldIdLst>
    <p:sldId id="259" r:id="rId2"/>
    <p:sldId id="287" r:id="rId3"/>
    <p:sldId id="288" r:id="rId4"/>
    <p:sldId id="278" r:id="rId5"/>
    <p:sldId id="282" r:id="rId6"/>
    <p:sldId id="277" r:id="rId7"/>
    <p:sldId id="283" r:id="rId8"/>
    <p:sldId id="286" r:id="rId9"/>
  </p:sldIdLst>
  <p:sldSz cx="9144000" cy="6858000" type="screen4x3"/>
  <p:notesSz cx="6797675" cy="9926638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9086" autoAdjust="0"/>
    <p:restoredTop sz="88968" autoAdjust="0"/>
  </p:normalViewPr>
  <p:slideViewPr>
    <p:cSldViewPr>
      <p:cViewPr varScale="1">
        <p:scale>
          <a:sx n="81" d="100"/>
          <a:sy n="81" d="100"/>
        </p:scale>
        <p:origin x="619" y="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6" d="100"/>
          <a:sy n="56" d="100"/>
        </p:scale>
        <p:origin x="-2874" y="-84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H</c:v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Banana_samples_results_hormons (4).xlsx]GA9'!$AG$12,'[Banana_samples_results_hormons (4).xlsx]GA9'!$AJ$12</c:f>
                <c:numCache>
                  <c:formatCode>General</c:formatCode>
                  <c:ptCount val="2"/>
                  <c:pt idx="0">
                    <c:v>0.1707298419896558</c:v>
                  </c:pt>
                  <c:pt idx="1">
                    <c:v>0.26172246697704343</c:v>
                  </c:pt>
                </c:numCache>
              </c:numRef>
            </c:plus>
            <c:minus>
              <c:numRef>
                <c:f>'[Banana_samples_results_hormons (4).xlsx]GA9'!$AG$12,'[Banana_samples_results_hormons (4).xlsx]GA9'!$AJ$12</c:f>
                <c:numCache>
                  <c:formatCode>General</c:formatCode>
                  <c:ptCount val="2"/>
                  <c:pt idx="0">
                    <c:v>0.1707298419896558</c:v>
                  </c:pt>
                  <c:pt idx="1">
                    <c:v>0.26172246697704343</c:v>
                  </c:pt>
                </c:numCache>
              </c:numRef>
            </c:minus>
            <c:spPr>
              <a:ln w="25400"/>
            </c:spPr>
          </c:errBars>
          <c:cat>
            <c:strLit>
              <c:ptCount val="2"/>
              <c:pt idx="0">
                <c:v>WT</c:v>
              </c:pt>
              <c:pt idx="1">
                <c:v>32</c:v>
              </c:pt>
            </c:strLit>
          </c:cat>
          <c:val>
            <c:numRef>
              <c:f>'[Banana_samples_results_hormons (4).xlsx]GA9'!$AG$11,'[Banana_samples_results_hormons (4).xlsx]GA9'!$AJ$11</c:f>
              <c:numCache>
                <c:formatCode>0.00</c:formatCode>
                <c:ptCount val="2"/>
                <c:pt idx="0">
                  <c:v>1.7622684808265561</c:v>
                </c:pt>
                <c:pt idx="1">
                  <c:v>1.8716517979922369</c:v>
                </c:pt>
              </c:numCache>
            </c:numRef>
          </c:val>
        </c:ser>
        <c:ser>
          <c:idx val="1"/>
          <c:order val="1"/>
          <c:tx>
            <c:v>PB</c:v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Banana_samples_results_hormons (4).xlsx]GA9'!$AH$12,'[Banana_samples_results_hormons (4).xlsx]GA9'!$AK$12</c:f>
                <c:numCache>
                  <c:formatCode>General</c:formatCode>
                  <c:ptCount val="2"/>
                  <c:pt idx="0">
                    <c:v>0.25582144299545351</c:v>
                  </c:pt>
                  <c:pt idx="1">
                    <c:v>0.13087298632319916</c:v>
                  </c:pt>
                </c:numCache>
              </c:numRef>
            </c:plus>
            <c:minus>
              <c:numRef>
                <c:f>'[Banana_samples_results_hormons (4).xlsx]GA9'!$AH$12,'[Banana_samples_results_hormons (4).xlsx]GA9'!$AK$12</c:f>
                <c:numCache>
                  <c:formatCode>General</c:formatCode>
                  <c:ptCount val="2"/>
                  <c:pt idx="0">
                    <c:v>0.25582144299545351</c:v>
                  </c:pt>
                  <c:pt idx="1">
                    <c:v>0.13087298632319916</c:v>
                  </c:pt>
                </c:numCache>
              </c:numRef>
            </c:minus>
            <c:spPr>
              <a:ln w="25400">
                <a:solidFill>
                  <a:schemeClr val="tx1">
                    <a:shade val="95000"/>
                    <a:satMod val="105000"/>
                  </a:schemeClr>
                </a:solidFill>
              </a:ln>
            </c:spPr>
          </c:errBars>
          <c:cat>
            <c:strLit>
              <c:ptCount val="2"/>
              <c:pt idx="0">
                <c:v>WT</c:v>
              </c:pt>
              <c:pt idx="1">
                <c:v>32</c:v>
              </c:pt>
            </c:strLit>
          </c:cat>
          <c:val>
            <c:numRef>
              <c:f>'[Banana_samples_results_hormons (4).xlsx]GA9'!$AH$11,'[Banana_samples_results_hormons (4).xlsx]GA9'!$AK$11</c:f>
              <c:numCache>
                <c:formatCode>0.00</c:formatCode>
                <c:ptCount val="2"/>
                <c:pt idx="0">
                  <c:v>1.501276164709396</c:v>
                </c:pt>
                <c:pt idx="1">
                  <c:v>1.2749161897185919</c:v>
                </c:pt>
              </c:numCache>
            </c:numRef>
          </c:val>
        </c:ser>
        <c:ser>
          <c:idx val="2"/>
          <c:order val="2"/>
          <c:tx>
            <c:v>B</c:v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Banana_samples_results_hormons (4).xlsx]GA9'!$AI$12,'[Banana_samples_results_hormons (4).xlsx]GA9'!$AL$12</c:f>
                <c:numCache>
                  <c:formatCode>General</c:formatCode>
                  <c:ptCount val="2"/>
                  <c:pt idx="0">
                    <c:v>0.31022043272076899</c:v>
                  </c:pt>
                  <c:pt idx="1">
                    <c:v>0.31495497991106525</c:v>
                  </c:pt>
                </c:numCache>
              </c:numRef>
            </c:plus>
            <c:minus>
              <c:numRef>
                <c:f>'[Banana_samples_results_hormons (4).xlsx]GA9'!$AI$12,'[Banana_samples_results_hormons (4).xlsx]GA9'!$AL$12</c:f>
                <c:numCache>
                  <c:formatCode>General</c:formatCode>
                  <c:ptCount val="2"/>
                  <c:pt idx="0">
                    <c:v>0.31022043272076899</c:v>
                  </c:pt>
                  <c:pt idx="1">
                    <c:v>0.31495497991106525</c:v>
                  </c:pt>
                </c:numCache>
              </c:numRef>
            </c:minus>
            <c:spPr>
              <a:ln w="25400"/>
            </c:spPr>
          </c:errBars>
          <c:cat>
            <c:strLit>
              <c:ptCount val="2"/>
              <c:pt idx="0">
                <c:v>WT</c:v>
              </c:pt>
              <c:pt idx="1">
                <c:v>32</c:v>
              </c:pt>
            </c:strLit>
          </c:cat>
          <c:val>
            <c:numRef>
              <c:f>'[Banana_samples_results_hormons (4).xlsx]GA9'!$AI$11,'[Banana_samples_results_hormons (4).xlsx]GA9'!$AL$11</c:f>
              <c:numCache>
                <c:formatCode>0.00</c:formatCode>
                <c:ptCount val="2"/>
                <c:pt idx="0">
                  <c:v>2.1383748682948807</c:v>
                </c:pt>
                <c:pt idx="1">
                  <c:v>1.50701109666166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42117824"/>
        <c:axId val="-2042127072"/>
      </c:barChart>
      <c:catAx>
        <c:axId val="-20421178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-2042127072"/>
        <c:crosses val="autoZero"/>
        <c:auto val="1"/>
        <c:lblAlgn val="ctr"/>
        <c:lblOffset val="100"/>
        <c:noMultiLvlLbl val="0"/>
      </c:catAx>
      <c:valAx>
        <c:axId val="-2042127072"/>
        <c:scaling>
          <c:orientation val="minMax"/>
          <c:max val="3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-2042117824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89444444444444449"/>
          <c:y val="2.6137357830271119E-4"/>
          <c:w val="8.6307961504811844E-3"/>
          <c:h val="5.9662073490813657E-2"/>
        </c:manualLayout>
      </c:layout>
      <c:overlay val="0"/>
      <c:txPr>
        <a:bodyPr/>
        <a:lstStyle/>
        <a:p>
          <a:pPr>
            <a:defRPr sz="11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52016" y="0"/>
            <a:ext cx="2945659" cy="496332"/>
          </a:xfrm>
          <a:prstGeom prst="rect">
            <a:avLst/>
          </a:prstGeom>
        </p:spPr>
        <p:txBody>
          <a:bodyPr vert="horz" lIns="91430" tIns="45716" rIns="91430" bIns="45716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74" y="0"/>
            <a:ext cx="2945659" cy="496332"/>
          </a:xfrm>
          <a:prstGeom prst="rect">
            <a:avLst/>
          </a:prstGeom>
        </p:spPr>
        <p:txBody>
          <a:bodyPr vert="horz" lIns="91430" tIns="45716" rIns="91430" bIns="45716" rtlCol="1"/>
          <a:lstStyle>
            <a:lvl1pPr algn="l">
              <a:defRPr sz="1200"/>
            </a:lvl1pPr>
          </a:lstStyle>
          <a:p>
            <a:fld id="{4A7A7E1C-8E7A-4B0C-85EE-5A5F1871685E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0" tIns="45716" rIns="91430" bIns="45716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30" tIns="45716" rIns="91430" bIns="45716" rtlCol="1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52016" y="9428583"/>
            <a:ext cx="2945659" cy="496332"/>
          </a:xfrm>
          <a:prstGeom prst="rect">
            <a:avLst/>
          </a:prstGeom>
        </p:spPr>
        <p:txBody>
          <a:bodyPr vert="horz" lIns="91430" tIns="45716" rIns="91430" bIns="45716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74" y="9428583"/>
            <a:ext cx="2945659" cy="496332"/>
          </a:xfrm>
          <a:prstGeom prst="rect">
            <a:avLst/>
          </a:prstGeom>
        </p:spPr>
        <p:txBody>
          <a:bodyPr vert="horz" lIns="91430" tIns="45716" rIns="91430" bIns="45716" rtlCol="1" anchor="b"/>
          <a:lstStyle>
            <a:lvl1pPr algn="l">
              <a:defRPr sz="1200"/>
            </a:lvl1pPr>
          </a:lstStyle>
          <a:p>
            <a:fld id="{750BA208-1E8F-41E7-B28F-26222C98EC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002842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31709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1293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18487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0226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9277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72320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10134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99187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22875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21331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74688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1C1AE-3E78-4C6A-932E-3516A8887D24}" type="datetimeFigureOut">
              <a:rPr lang="he-IL" smtClean="0"/>
              <a:t>י"ט/אב/תשע"ח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82AA62-A13B-4448-8301-B10CDB0567F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51339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chart" Target="../charts/char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3"/>
          <p:cNvSpPr>
            <a:spLocks noChangeAspect="1"/>
          </p:cNvSpPr>
          <p:nvPr/>
        </p:nvSpPr>
        <p:spPr>
          <a:xfrm>
            <a:off x="903957" y="1849832"/>
            <a:ext cx="1723827" cy="1875978"/>
          </a:xfrm>
          <a:prstGeom prst="ellipse">
            <a:avLst/>
          </a:prstGeom>
          <a:solidFill>
            <a:srgbClr val="92D050">
              <a:alpha val="69000"/>
            </a:srgbClr>
          </a:solidFill>
          <a:ln>
            <a:solidFill>
              <a:srgbClr val="92D050">
                <a:alpha val="34000"/>
              </a:srgb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5" name="Oval 4"/>
          <p:cNvSpPr>
            <a:spLocks noChangeAspect="1"/>
          </p:cNvSpPr>
          <p:nvPr/>
        </p:nvSpPr>
        <p:spPr>
          <a:xfrm>
            <a:off x="1043610" y="1335502"/>
            <a:ext cx="2700300" cy="2957472"/>
          </a:xfrm>
          <a:prstGeom prst="ellipse">
            <a:avLst/>
          </a:prstGeom>
          <a:solidFill>
            <a:schemeClr val="accent6">
              <a:lumMod val="60000"/>
              <a:lumOff val="40000"/>
              <a:alpha val="53000"/>
            </a:schemeClr>
          </a:solidFill>
          <a:ln>
            <a:solidFill>
              <a:schemeClr val="accent6">
                <a:lumMod val="60000"/>
                <a:lumOff val="40000"/>
                <a:alpha val="29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6" name="TextBox 5"/>
          <p:cNvSpPr txBox="1"/>
          <p:nvPr/>
        </p:nvSpPr>
        <p:spPr>
          <a:xfrm>
            <a:off x="683568" y="2652955"/>
            <a:ext cx="432048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 smtClean="0"/>
              <a:t>84</a:t>
            </a:r>
            <a:endParaRPr lang="he-IL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403648" y="2652955"/>
            <a:ext cx="64807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 smtClean="0"/>
              <a:t>608</a:t>
            </a:r>
            <a:endParaRPr lang="he-IL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771800" y="2652955"/>
            <a:ext cx="64807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 smtClean="0"/>
              <a:t>766</a:t>
            </a:r>
            <a:endParaRPr lang="he-IL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87803" y="1887875"/>
            <a:ext cx="1044116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sz="1400" b="1" dirty="0" err="1" smtClean="0"/>
              <a:t>RNAi</a:t>
            </a:r>
            <a:r>
              <a:rPr lang="en-US" sz="1400" b="1" dirty="0" smtClean="0"/>
              <a:t> 32 (FDR&lt;0.05)</a:t>
            </a:r>
            <a:endParaRPr lang="he-IL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311980" y="1183558"/>
            <a:ext cx="1180797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sz="1400" b="1" dirty="0" smtClean="0"/>
              <a:t>Antisense </a:t>
            </a:r>
            <a:r>
              <a:rPr lang="en-US" sz="1400" b="1" dirty="0"/>
              <a:t>44 (FDR&lt;0.05)</a:t>
            </a:r>
            <a:endParaRPr lang="he-IL" sz="1400" b="1" dirty="0"/>
          </a:p>
        </p:txBody>
      </p:sp>
      <p:sp>
        <p:nvSpPr>
          <p:cNvPr id="13" name="Oval 12"/>
          <p:cNvSpPr>
            <a:spLocks noChangeAspect="1"/>
          </p:cNvSpPr>
          <p:nvPr/>
        </p:nvSpPr>
        <p:spPr>
          <a:xfrm>
            <a:off x="5724130" y="1335624"/>
            <a:ext cx="2700300" cy="2957472"/>
          </a:xfrm>
          <a:prstGeom prst="ellipse">
            <a:avLst/>
          </a:prstGeom>
          <a:solidFill>
            <a:schemeClr val="accent6">
              <a:lumMod val="60000"/>
              <a:lumOff val="40000"/>
              <a:alpha val="53000"/>
            </a:schemeClr>
          </a:solidFill>
          <a:ln>
            <a:solidFill>
              <a:schemeClr val="accent6">
                <a:lumMod val="60000"/>
                <a:lumOff val="40000"/>
                <a:alpha val="29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4" name="Oval 13"/>
          <p:cNvSpPr>
            <a:spLocks noChangeAspect="1"/>
          </p:cNvSpPr>
          <p:nvPr/>
        </p:nvSpPr>
        <p:spPr>
          <a:xfrm>
            <a:off x="5220072" y="1517177"/>
            <a:ext cx="2376264" cy="2602576"/>
          </a:xfrm>
          <a:prstGeom prst="ellipse">
            <a:avLst/>
          </a:prstGeom>
          <a:solidFill>
            <a:srgbClr val="92D050">
              <a:alpha val="53000"/>
            </a:srgbClr>
          </a:solidFill>
          <a:ln>
            <a:solidFill>
              <a:srgbClr val="92D050">
                <a:alpha val="29000"/>
              </a:srgb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5" name="TextBox 14"/>
          <p:cNvSpPr txBox="1"/>
          <p:nvPr/>
        </p:nvSpPr>
        <p:spPr>
          <a:xfrm>
            <a:off x="5220072" y="2653226"/>
            <a:ext cx="432048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 smtClean="0"/>
              <a:t>311</a:t>
            </a:r>
            <a:endParaRPr lang="he-IL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228184" y="2653226"/>
            <a:ext cx="64807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 smtClean="0"/>
              <a:t>905</a:t>
            </a:r>
            <a:endParaRPr lang="he-IL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7524328" y="2653226"/>
            <a:ext cx="64807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 smtClean="0"/>
              <a:t>469</a:t>
            </a:r>
            <a:endParaRPr lang="he-IL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4391981" y="1876073"/>
            <a:ext cx="1116124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sz="1400" b="1" dirty="0" smtClean="0"/>
              <a:t>RNAi 32 (FDR&lt;0.1)</a:t>
            </a:r>
            <a:endParaRPr lang="he-IL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7850307" y="1087318"/>
            <a:ext cx="1224136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sz="1400" b="1" dirty="0" smtClean="0"/>
              <a:t>Antisense </a:t>
            </a:r>
            <a:r>
              <a:rPr lang="en-US" sz="1400" b="1" dirty="0"/>
              <a:t>44 (FDR&lt;0.05)</a:t>
            </a:r>
            <a:endParaRPr lang="he-IL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-22085" y="-36677"/>
            <a:ext cx="200179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 smtClean="0"/>
              <a:t>Figure S1:</a:t>
            </a:r>
            <a:endParaRPr lang="he-IL" dirty="0"/>
          </a:p>
        </p:txBody>
      </p:sp>
      <p:sp>
        <p:nvSpPr>
          <p:cNvPr id="22" name="TextBox 21"/>
          <p:cNvSpPr txBox="1"/>
          <p:nvPr/>
        </p:nvSpPr>
        <p:spPr>
          <a:xfrm>
            <a:off x="1002719" y="814226"/>
            <a:ext cx="32412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 smtClean="0"/>
              <a:t>A</a:t>
            </a:r>
            <a:endParaRPr lang="he-IL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5139470" y="781707"/>
            <a:ext cx="314509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 smtClean="0"/>
              <a:t>B</a:t>
            </a:r>
            <a:endParaRPr lang="he-IL" b="1" dirty="0"/>
          </a:p>
        </p:txBody>
      </p:sp>
    </p:spTree>
    <p:extLst>
      <p:ext uri="{BB962C8B-B14F-4D97-AF65-F5344CB8AC3E}">
        <p14:creationId xmlns:p14="http://schemas.microsoft.com/office/powerpoint/2010/main" val="22015103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763688" y="908720"/>
            <a:ext cx="5076056" cy="3225289"/>
            <a:chOff x="4067944" y="3588087"/>
            <a:chExt cx="5076056" cy="3225289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" t="412" r="39142" b="74526"/>
            <a:stretch/>
          </p:blipFill>
          <p:spPr bwMode="auto">
            <a:xfrm>
              <a:off x="6622240" y="3588087"/>
              <a:ext cx="2472593" cy="255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188" t="3740" r="5888" b="73967"/>
            <a:stretch/>
          </p:blipFill>
          <p:spPr bwMode="auto">
            <a:xfrm>
              <a:off x="5578024" y="3600000"/>
              <a:ext cx="1152000" cy="252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Rectangle 6"/>
            <p:cNvSpPr/>
            <p:nvPr/>
          </p:nvSpPr>
          <p:spPr>
            <a:xfrm rot="5400000">
              <a:off x="6457744" y="6124273"/>
              <a:ext cx="166126" cy="159905"/>
            </a:xfrm>
            <a:prstGeom prst="rect">
              <a:avLst/>
            </a:prstGeom>
            <a:solidFill>
              <a:sysClr val="window" lastClr="FFFFFF"/>
            </a:solidFill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  <p:txBody>
            <a:bodyPr rtlCol="1" anchor="ctr"/>
            <a:lstStyle/>
            <a:p>
              <a:pPr algn="ctr" rtl="1">
                <a:spcAft>
                  <a:spcPts val="0"/>
                </a:spcAft>
              </a:pPr>
              <a:r>
                <a:rPr lang="en-US" sz="1800" kern="1200" dirty="0">
                  <a:solidFill>
                    <a:srgbClr val="FFFFFF"/>
                  </a:solidFill>
                  <a:effectLst/>
                  <a:latin typeface="Calibri"/>
                  <a:ea typeface="Times New Roman"/>
                  <a:cs typeface="Arial"/>
                </a:rPr>
                <a:t>44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8" name="Straight Connector 7"/>
            <p:cNvCxnSpPr/>
            <p:nvPr/>
          </p:nvCxnSpPr>
          <p:spPr>
            <a:xfrm rot="5400000">
              <a:off x="6336000" y="6328815"/>
              <a:ext cx="83054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9" name="Straight Connector 8"/>
            <p:cNvCxnSpPr/>
            <p:nvPr/>
          </p:nvCxnSpPr>
          <p:spPr>
            <a:xfrm rot="5400000">
              <a:off x="5958000" y="6328243"/>
              <a:ext cx="83054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0" name="Straight Connector 9"/>
            <p:cNvCxnSpPr/>
            <p:nvPr/>
          </p:nvCxnSpPr>
          <p:spPr>
            <a:xfrm rot="5400000">
              <a:off x="5580000" y="6329388"/>
              <a:ext cx="83054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" name="Straight Connector 10"/>
            <p:cNvCxnSpPr/>
            <p:nvPr/>
          </p:nvCxnSpPr>
          <p:spPr>
            <a:xfrm flipH="1">
              <a:off x="5529396" y="6287880"/>
              <a:ext cx="1169376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2" name="TextBox 16"/>
            <p:cNvSpPr txBox="1"/>
            <p:nvPr/>
          </p:nvSpPr>
          <p:spPr>
            <a:xfrm>
              <a:off x="4968794" y="6536377"/>
              <a:ext cx="2302998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1"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-</a:t>
              </a: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log</a:t>
              </a:r>
              <a:r>
                <a:rPr lang="en-US" sz="7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2</a:t>
              </a: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FDR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3" name="TextBox 17"/>
            <p:cNvSpPr txBox="1"/>
            <p:nvPr/>
          </p:nvSpPr>
          <p:spPr>
            <a:xfrm>
              <a:off x="6230042" y="6372000"/>
              <a:ext cx="286174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3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4" name="TextBox 18"/>
            <p:cNvSpPr txBox="1"/>
            <p:nvPr/>
          </p:nvSpPr>
          <p:spPr>
            <a:xfrm>
              <a:off x="5670000" y="6370355"/>
              <a:ext cx="449975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6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5" name="TextBox 19"/>
            <p:cNvSpPr txBox="1"/>
            <p:nvPr/>
          </p:nvSpPr>
          <p:spPr>
            <a:xfrm>
              <a:off x="5364088" y="6370355"/>
              <a:ext cx="378748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9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6" name="Oval 15"/>
            <p:cNvSpPr>
              <a:spLocks noChangeAspect="1"/>
            </p:cNvSpPr>
            <p:nvPr/>
          </p:nvSpPr>
          <p:spPr>
            <a:xfrm rot="10800000">
              <a:off x="4618367" y="5125173"/>
              <a:ext cx="43593" cy="42640"/>
            </a:xfrm>
            <a:prstGeom prst="ellipse">
              <a:avLst/>
            </a:prstGeom>
            <a:solidFill>
              <a:sysClr val="window" lastClr="FFFFFF"/>
            </a:solidFill>
            <a:ln w="25400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1" anchor="ctr"/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US" sz="1100">
                  <a:effectLst/>
                  <a:latin typeface="Calibri"/>
                  <a:ea typeface="Times New Roman"/>
                  <a:cs typeface="Arial"/>
                </a:rPr>
                <a:t> </a:t>
              </a:r>
              <a:endParaRPr lang="en-US" sz="1100">
                <a:effectLst/>
                <a:latin typeface="Calibri"/>
                <a:ea typeface="Calibri"/>
                <a:cs typeface="Arial"/>
              </a:endParaRPr>
            </a:p>
          </p:txBody>
        </p:sp>
        <p:sp>
          <p:nvSpPr>
            <p:cNvPr id="17" name="Oval 16"/>
            <p:cNvSpPr>
              <a:spLocks noChangeAspect="1"/>
            </p:cNvSpPr>
            <p:nvPr/>
          </p:nvSpPr>
          <p:spPr>
            <a:xfrm rot="10800000">
              <a:off x="4536606" y="4417154"/>
              <a:ext cx="301940" cy="295340"/>
            </a:xfrm>
            <a:prstGeom prst="ellipse">
              <a:avLst/>
            </a:prstGeom>
            <a:solidFill>
              <a:sysClr val="window" lastClr="FFFFFF"/>
            </a:solidFill>
            <a:ln w="25400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1" anchor="ctr"/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US" sz="1100">
                  <a:effectLst/>
                  <a:latin typeface="Calibri"/>
                  <a:ea typeface="Times New Roman"/>
                  <a:cs typeface="Arial"/>
                </a:rPr>
                <a:t> </a:t>
              </a:r>
              <a:endParaRPr lang="en-US" sz="1100">
                <a:effectLst/>
                <a:latin typeface="Calibri"/>
                <a:ea typeface="Calibri"/>
                <a:cs typeface="Arial"/>
              </a:endParaRPr>
            </a:p>
          </p:txBody>
        </p:sp>
        <p:sp>
          <p:nvSpPr>
            <p:cNvPr id="18" name="TextBox 38"/>
            <p:cNvSpPr txBox="1"/>
            <p:nvPr/>
          </p:nvSpPr>
          <p:spPr>
            <a:xfrm rot="5400000">
              <a:off x="4254936" y="4425028"/>
              <a:ext cx="341760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50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9" name="TextBox 39"/>
            <p:cNvSpPr txBox="1"/>
            <p:nvPr/>
          </p:nvSpPr>
          <p:spPr>
            <a:xfrm rot="5400000">
              <a:off x="4294209" y="4981804"/>
              <a:ext cx="263213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2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20" name="TextBox 40"/>
            <p:cNvSpPr txBox="1"/>
            <p:nvPr/>
          </p:nvSpPr>
          <p:spPr>
            <a:xfrm rot="5400000">
              <a:off x="3240464" y="4711238"/>
              <a:ext cx="1993514" cy="33855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1">
                <a:spcAft>
                  <a:spcPts val="0"/>
                </a:spcAft>
              </a:pPr>
              <a:r>
                <a:rPr lang="en-US" sz="16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# genes</a:t>
              </a:r>
              <a:endParaRPr lang="en-US" sz="16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622240" y="6165720"/>
              <a:ext cx="2521760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400" b="1" dirty="0" smtClean="0"/>
                <a:t>GO  of lower expressed genes in </a:t>
              </a:r>
              <a:r>
                <a:rPr lang="en-US" sz="1400" b="1" i="1" dirty="0" smtClean="0"/>
                <a:t>MaMADS2 </a:t>
              </a:r>
              <a:r>
                <a:rPr lang="en-US" sz="1400" b="1" dirty="0" smtClean="0"/>
                <a:t>suppressed lines</a:t>
              </a:r>
              <a:endParaRPr lang="he-IL" sz="1400" b="1" dirty="0"/>
            </a:p>
          </p:txBody>
        </p:sp>
        <p:sp>
          <p:nvSpPr>
            <p:cNvPr id="22" name="Left Brace 21"/>
            <p:cNvSpPr/>
            <p:nvPr/>
          </p:nvSpPr>
          <p:spPr>
            <a:xfrm>
              <a:off x="5459244" y="3600000"/>
              <a:ext cx="144000" cy="288000"/>
            </a:xfrm>
            <a:prstGeom prst="leftBrace">
              <a:avLst/>
            </a:prstGeom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23" name="Left Brace 22"/>
            <p:cNvSpPr/>
            <p:nvPr/>
          </p:nvSpPr>
          <p:spPr>
            <a:xfrm>
              <a:off x="5460688" y="4005064"/>
              <a:ext cx="144000" cy="266400"/>
            </a:xfrm>
            <a:prstGeom prst="leftBrace">
              <a:avLst/>
            </a:prstGeom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24" name="Left Brace 23"/>
            <p:cNvSpPr/>
            <p:nvPr/>
          </p:nvSpPr>
          <p:spPr>
            <a:xfrm>
              <a:off x="5460688" y="4365136"/>
              <a:ext cx="144000" cy="1368120"/>
            </a:xfrm>
            <a:prstGeom prst="leftBrace">
              <a:avLst/>
            </a:prstGeom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25" name="Left Brace 24"/>
            <p:cNvSpPr/>
            <p:nvPr/>
          </p:nvSpPr>
          <p:spPr>
            <a:xfrm>
              <a:off x="5460688" y="5805296"/>
              <a:ext cx="144000" cy="144000"/>
            </a:xfrm>
            <a:prstGeom prst="leftBrace">
              <a:avLst/>
            </a:prstGeom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26" name="Left Brace 25"/>
            <p:cNvSpPr/>
            <p:nvPr/>
          </p:nvSpPr>
          <p:spPr>
            <a:xfrm>
              <a:off x="5460688" y="6021304"/>
              <a:ext cx="144000" cy="144000"/>
            </a:xfrm>
            <a:prstGeom prst="leftBrace">
              <a:avLst/>
            </a:prstGeom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716016" y="3594502"/>
              <a:ext cx="899592" cy="33855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signal transduction</a:t>
              </a:r>
              <a:endParaRPr lang="he-IL" sz="8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716016" y="3954542"/>
              <a:ext cx="899592" cy="33855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protein complex assembly</a:t>
              </a:r>
              <a:endParaRPr lang="he-IL" sz="8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716016" y="4839543"/>
              <a:ext cx="899592" cy="461665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cell organization and cytoskeleton</a:t>
              </a:r>
              <a:endParaRPr lang="he-IL" sz="8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716016" y="5760000"/>
              <a:ext cx="899592" cy="21544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cell wall</a:t>
              </a:r>
              <a:endParaRPr lang="he-IL" sz="8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716016" y="5949280"/>
              <a:ext cx="899592" cy="33855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biosynthesis related</a:t>
              </a:r>
              <a:r>
                <a:rPr lang="he-IL" sz="800" b="1" dirty="0"/>
                <a:t> </a:t>
              </a: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1619672" y="62068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</a:t>
            </a:r>
            <a:endParaRPr lang="en-GB" sz="12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-22085" y="-36677"/>
            <a:ext cx="200179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 smtClean="0"/>
              <a:t>Figure S2: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37871488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592567" y="5625560"/>
            <a:ext cx="2345707" cy="1007373"/>
            <a:chOff x="1730486" y="5085923"/>
            <a:chExt cx="2345707" cy="1007373"/>
          </a:xfrm>
        </p:grpSpPr>
        <p:grpSp>
          <p:nvGrpSpPr>
            <p:cNvPr id="3" name="Group 2"/>
            <p:cNvGrpSpPr/>
            <p:nvPr/>
          </p:nvGrpSpPr>
          <p:grpSpPr>
            <a:xfrm>
              <a:off x="1730486" y="5085923"/>
              <a:ext cx="2345707" cy="719341"/>
              <a:chOff x="1730486" y="5085923"/>
              <a:chExt cx="2345707" cy="719341"/>
            </a:xfrm>
          </p:grpSpPr>
          <p:sp>
            <p:nvSpPr>
              <p:cNvPr id="13" name="Oval 12"/>
              <p:cNvSpPr>
                <a:spLocks noChangeAspect="1"/>
              </p:cNvSpPr>
              <p:nvPr/>
            </p:nvSpPr>
            <p:spPr>
              <a:xfrm rot="5400000">
                <a:off x="3923646" y="5438124"/>
                <a:ext cx="36061" cy="34132"/>
              </a:xfrm>
              <a:prstGeom prst="ellipse">
                <a:avLst/>
              </a:prstGeom>
              <a:solidFill>
                <a:sysClr val="window" lastClr="FFFFFF"/>
              </a:solidFill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  <p:txBody>
              <a:bodyPr rtlCol="1" anchor="ctr"/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US" sz="1100">
                    <a:effectLst/>
                    <a:latin typeface="Calibri"/>
                    <a:ea typeface="Times New Roman"/>
                    <a:cs typeface="Arial"/>
                  </a:rPr>
                  <a:t> </a:t>
                </a:r>
                <a:endParaRPr lang="en-US" sz="1100">
                  <a:effectLst/>
                  <a:latin typeface="Calibri"/>
                  <a:ea typeface="Calibri"/>
                  <a:cs typeface="Arial"/>
                </a:endParaRPr>
              </a:p>
            </p:txBody>
          </p:sp>
          <p:sp>
            <p:nvSpPr>
              <p:cNvPr id="14" name="Oval 13"/>
              <p:cNvSpPr>
                <a:spLocks noChangeAspect="1"/>
              </p:cNvSpPr>
              <p:nvPr/>
            </p:nvSpPr>
            <p:spPr>
              <a:xfrm rot="5400000">
                <a:off x="3351191" y="5297766"/>
                <a:ext cx="249771" cy="236407"/>
              </a:xfrm>
              <a:prstGeom prst="ellipse">
                <a:avLst/>
              </a:prstGeom>
              <a:solidFill>
                <a:sysClr val="window" lastClr="FFFFFF"/>
              </a:solidFill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  <p:txBody>
              <a:bodyPr rtlCol="1" anchor="ctr"/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US" sz="1100">
                    <a:effectLst/>
                    <a:latin typeface="Calibri"/>
                    <a:ea typeface="Times New Roman"/>
                    <a:cs typeface="Arial"/>
                  </a:rPr>
                  <a:t> </a:t>
                </a:r>
                <a:endParaRPr lang="en-US" sz="1100">
                  <a:effectLst/>
                  <a:latin typeface="Calibri"/>
                  <a:ea typeface="Calibri"/>
                  <a:cs typeface="Arial"/>
                </a:endParaRPr>
              </a:p>
            </p:txBody>
          </p:sp>
          <p:sp>
            <p:nvSpPr>
              <p:cNvPr id="15" name="Oval 14"/>
              <p:cNvSpPr>
                <a:spLocks noChangeAspect="1"/>
              </p:cNvSpPr>
              <p:nvPr/>
            </p:nvSpPr>
            <p:spPr>
              <a:xfrm rot="5400000">
                <a:off x="2625967" y="5192947"/>
                <a:ext cx="374657" cy="354611"/>
              </a:xfrm>
              <a:prstGeom prst="ellipse">
                <a:avLst/>
              </a:prstGeom>
              <a:solidFill>
                <a:sysClr val="window" lastClr="FFFFFF"/>
              </a:solidFill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  <p:txBody>
              <a:bodyPr rtlCol="1" anchor="ctr"/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US" sz="1100">
                    <a:effectLst/>
                    <a:latin typeface="Calibri"/>
                    <a:ea typeface="Times New Roman"/>
                    <a:cs typeface="Arial"/>
                  </a:rPr>
                  <a:t> </a:t>
                </a:r>
                <a:endParaRPr lang="en-US" sz="1100">
                  <a:effectLst/>
                  <a:latin typeface="Calibri"/>
                  <a:ea typeface="Calibri"/>
                  <a:cs typeface="Arial"/>
                </a:endParaRPr>
              </a:p>
            </p:txBody>
          </p:sp>
          <p:sp>
            <p:nvSpPr>
              <p:cNvPr id="16" name="Oval 15"/>
              <p:cNvSpPr>
                <a:spLocks noChangeAspect="1"/>
              </p:cNvSpPr>
              <p:nvPr/>
            </p:nvSpPr>
            <p:spPr>
              <a:xfrm rot="5400000">
                <a:off x="1717122" y="5099287"/>
                <a:ext cx="499543" cy="472815"/>
              </a:xfrm>
              <a:prstGeom prst="ellipse">
                <a:avLst/>
              </a:prstGeom>
              <a:solidFill>
                <a:sysClr val="window" lastClr="FFFFFF"/>
              </a:solidFill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  <p:txBody>
              <a:bodyPr rtlCol="1" anchor="ctr"/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US" sz="1100">
                    <a:effectLst/>
                    <a:latin typeface="Calibri"/>
                    <a:ea typeface="Times New Roman"/>
                    <a:cs typeface="Arial"/>
                  </a:rPr>
                  <a:t> </a:t>
                </a:r>
                <a:endParaRPr lang="en-US" sz="1100">
                  <a:effectLst/>
                  <a:latin typeface="Calibri"/>
                  <a:ea typeface="Calibri"/>
                  <a:cs typeface="Arial"/>
                </a:endParaRPr>
              </a:p>
            </p:txBody>
          </p:sp>
          <p:sp>
            <p:nvSpPr>
              <p:cNvPr id="17" name="TextBox 37"/>
              <p:cNvSpPr txBox="1"/>
              <p:nvPr/>
            </p:nvSpPr>
            <p:spPr>
              <a:xfrm>
                <a:off x="1733251" y="5534555"/>
                <a:ext cx="382872" cy="270709"/>
              </a:xfrm>
              <a:prstGeom prst="rect">
                <a:avLst/>
              </a:prstGeom>
              <a:noFill/>
            </p:spPr>
            <p:txBody>
              <a:bodyPr wrap="square" rtlCol="1">
                <a:noAutofit/>
              </a:bodyPr>
              <a:lstStyle/>
              <a:p>
                <a:pPr algn="r" rtl="1">
                  <a:spcAft>
                    <a:spcPts val="0"/>
                  </a:spcAft>
                </a:pPr>
                <a:r>
                  <a:rPr lang="en-US" sz="1200" b="1" kern="1200" dirty="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Arial"/>
                  </a:rPr>
                  <a:t>200</a:t>
                </a:r>
                <a:endParaRPr lang="en-US" sz="1200" b="1" dirty="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18" name="TextBox 43"/>
              <p:cNvSpPr txBox="1"/>
              <p:nvPr/>
            </p:nvSpPr>
            <p:spPr>
              <a:xfrm>
                <a:off x="2591511" y="5534555"/>
                <a:ext cx="382872" cy="270709"/>
              </a:xfrm>
              <a:prstGeom prst="rect">
                <a:avLst/>
              </a:prstGeom>
              <a:noFill/>
            </p:spPr>
            <p:txBody>
              <a:bodyPr wrap="square" rtlCol="1">
                <a:noAutofit/>
              </a:bodyPr>
              <a:lstStyle/>
              <a:p>
                <a:pPr algn="r" rtl="1">
                  <a:spcAft>
                    <a:spcPts val="0"/>
                  </a:spcAft>
                </a:pPr>
                <a:r>
                  <a:rPr lang="en-US" sz="1200" b="1" kern="1200" dirty="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Arial"/>
                  </a:rPr>
                  <a:t>100</a:t>
                </a:r>
                <a:endParaRPr lang="en-US" sz="1200" b="1" dirty="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19" name="TextBox 44"/>
              <p:cNvSpPr txBox="1"/>
              <p:nvPr/>
            </p:nvSpPr>
            <p:spPr>
              <a:xfrm>
                <a:off x="3284105" y="5534913"/>
                <a:ext cx="315564" cy="270226"/>
              </a:xfrm>
              <a:prstGeom prst="rect">
                <a:avLst/>
              </a:prstGeom>
              <a:noFill/>
            </p:spPr>
            <p:txBody>
              <a:bodyPr wrap="square" rtlCol="1">
                <a:noAutofit/>
              </a:bodyPr>
              <a:lstStyle/>
              <a:p>
                <a:pPr algn="r" rtl="1">
                  <a:spcAft>
                    <a:spcPts val="0"/>
                  </a:spcAft>
                </a:pPr>
                <a:r>
                  <a:rPr lang="en-US" sz="1200" b="1" kern="1200" dirty="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Arial"/>
                  </a:rPr>
                  <a:t>50</a:t>
                </a:r>
                <a:endParaRPr lang="en-US" sz="1200" b="1" dirty="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0" name="TextBox 45"/>
              <p:cNvSpPr txBox="1"/>
              <p:nvPr/>
            </p:nvSpPr>
            <p:spPr>
              <a:xfrm>
                <a:off x="3833154" y="5534913"/>
                <a:ext cx="243039" cy="270226"/>
              </a:xfrm>
              <a:prstGeom prst="rect">
                <a:avLst/>
              </a:prstGeom>
              <a:noFill/>
            </p:spPr>
            <p:txBody>
              <a:bodyPr wrap="square" rtlCol="1">
                <a:noAutofit/>
              </a:bodyPr>
              <a:lstStyle/>
              <a:p>
                <a:pPr algn="r" rtl="1">
                  <a:spcAft>
                    <a:spcPts val="0"/>
                  </a:spcAft>
                </a:pPr>
                <a:r>
                  <a:rPr lang="en-US" sz="1200" b="1" kern="1200" dirty="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Arial"/>
                  </a:rPr>
                  <a:t>2</a:t>
                </a:r>
                <a:endParaRPr lang="en-US" sz="1200" b="1" dirty="0">
                  <a:effectLst/>
                  <a:latin typeface="Times New Roman"/>
                  <a:ea typeface="Times New Roman"/>
                </a:endParaRPr>
              </a:p>
            </p:txBody>
          </p:sp>
        </p:grpSp>
        <p:sp>
          <p:nvSpPr>
            <p:cNvPr id="12" name="TextBox 2"/>
            <p:cNvSpPr txBox="1"/>
            <p:nvPr/>
          </p:nvSpPr>
          <p:spPr>
            <a:xfrm>
              <a:off x="1835258" y="5732995"/>
              <a:ext cx="1790004" cy="36030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noAutofit/>
            </a:bodyPr>
            <a:lstStyle/>
            <a:p>
              <a:pPr algn="ctr" rtl="1">
                <a:spcAft>
                  <a:spcPts val="0"/>
                </a:spcAft>
              </a:pPr>
              <a:r>
                <a:rPr lang="en-US" sz="16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# genes</a:t>
              </a:r>
              <a:endParaRPr lang="en-US" sz="1600" b="1" dirty="0">
                <a:effectLst/>
                <a:latin typeface="Times New Roman"/>
                <a:ea typeface="Times New Roman"/>
              </a:endParaRP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4957194" y="5548112"/>
            <a:ext cx="3338054" cy="64633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b="1" dirty="0" smtClean="0"/>
              <a:t>GO of higher expressed genes in </a:t>
            </a:r>
            <a:r>
              <a:rPr lang="en-US" b="1" i="1" dirty="0" smtClean="0"/>
              <a:t>MaMADS2</a:t>
            </a:r>
            <a:r>
              <a:rPr lang="en-US" b="1" dirty="0" smtClean="0"/>
              <a:t> suppressed lines</a:t>
            </a:r>
            <a:endParaRPr lang="he-IL" b="1" dirty="0"/>
          </a:p>
        </p:txBody>
      </p:sp>
      <p:grpSp>
        <p:nvGrpSpPr>
          <p:cNvPr id="29" name="Group 28"/>
          <p:cNvGrpSpPr/>
          <p:nvPr/>
        </p:nvGrpSpPr>
        <p:grpSpPr>
          <a:xfrm>
            <a:off x="8638799" y="2301031"/>
            <a:ext cx="690138" cy="3094127"/>
            <a:chOff x="8341698" y="2427754"/>
            <a:chExt cx="680151" cy="2988214"/>
          </a:xfrm>
        </p:grpSpPr>
        <p:sp>
          <p:nvSpPr>
            <p:cNvPr id="9" name="Rectangle 8"/>
            <p:cNvSpPr/>
            <p:nvPr/>
          </p:nvSpPr>
          <p:spPr>
            <a:xfrm>
              <a:off x="8341698" y="2427754"/>
              <a:ext cx="130058" cy="210742"/>
            </a:xfrm>
            <a:prstGeom prst="rect">
              <a:avLst/>
            </a:prstGeom>
            <a:solidFill>
              <a:sysClr val="window" lastClr="FFFFFF"/>
            </a:solidFill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  <p:txBody>
            <a:bodyPr rtlCol="1" anchor="ctr"/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US" sz="1100">
                  <a:effectLst/>
                  <a:latin typeface="Calibri"/>
                  <a:ea typeface="Times New Roman"/>
                  <a:cs typeface="Arial"/>
                </a:rPr>
                <a:t> </a:t>
              </a:r>
              <a:endParaRPr lang="en-US" sz="1100">
                <a:effectLst/>
                <a:latin typeface="Calibri"/>
                <a:ea typeface="Calibri"/>
                <a:cs typeface="Arial"/>
              </a:endParaRPr>
            </a:p>
          </p:txBody>
        </p:sp>
        <p:cxnSp>
          <p:nvCxnSpPr>
            <p:cNvPr id="21" name="Straight Connector 20"/>
            <p:cNvCxnSpPr/>
            <p:nvPr/>
          </p:nvCxnSpPr>
          <p:spPr>
            <a:xfrm>
              <a:off x="8544920" y="2546513"/>
              <a:ext cx="0" cy="1965895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23" name="Straight Connector 22"/>
            <p:cNvCxnSpPr/>
            <p:nvPr/>
          </p:nvCxnSpPr>
          <p:spPr>
            <a:xfrm>
              <a:off x="8543989" y="2951984"/>
              <a:ext cx="66481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24" name="Straight Connector 23"/>
            <p:cNvCxnSpPr/>
            <p:nvPr/>
          </p:nvCxnSpPr>
          <p:spPr>
            <a:xfrm>
              <a:off x="8544905" y="3275984"/>
              <a:ext cx="66481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25" name="Straight Connector 24"/>
            <p:cNvCxnSpPr/>
            <p:nvPr/>
          </p:nvCxnSpPr>
          <p:spPr>
            <a:xfrm>
              <a:off x="8544447" y="3599984"/>
              <a:ext cx="66481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26" name="Straight Connector 25"/>
            <p:cNvCxnSpPr/>
            <p:nvPr/>
          </p:nvCxnSpPr>
          <p:spPr>
            <a:xfrm>
              <a:off x="8544905" y="3923984"/>
              <a:ext cx="66481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27" name="Straight Connector 26"/>
            <p:cNvCxnSpPr/>
            <p:nvPr/>
          </p:nvCxnSpPr>
          <p:spPr>
            <a:xfrm>
              <a:off x="8544447" y="4247984"/>
              <a:ext cx="66481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8" name="TextBox 33"/>
            <p:cNvSpPr txBox="1"/>
            <p:nvPr/>
          </p:nvSpPr>
          <p:spPr>
            <a:xfrm rot="16200000">
              <a:off x="8182092" y="4576212"/>
              <a:ext cx="1258019" cy="421494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/>
            <a:p>
              <a:pPr algn="ctr" rtl="1"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-</a:t>
              </a: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log</a:t>
              </a:r>
              <a:r>
                <a:rPr lang="en-US" sz="7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2</a:t>
              </a: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FDR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30" name="TextBox 38"/>
            <p:cNvSpPr txBox="1"/>
            <p:nvPr/>
          </p:nvSpPr>
          <p:spPr>
            <a:xfrm rot="16200000">
              <a:off x="8620455" y="2825984"/>
              <a:ext cx="236729" cy="255767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he-IL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4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31" name="TextBox 39"/>
            <p:cNvSpPr txBox="1"/>
            <p:nvPr/>
          </p:nvSpPr>
          <p:spPr>
            <a:xfrm rot="16200000">
              <a:off x="8620455" y="3149984"/>
              <a:ext cx="236729" cy="255767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8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32" name="TextBox 40"/>
            <p:cNvSpPr txBox="1"/>
            <p:nvPr/>
          </p:nvSpPr>
          <p:spPr>
            <a:xfrm rot="16200000">
              <a:off x="8558230" y="3509984"/>
              <a:ext cx="361183" cy="255767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12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33" name="TextBox 41"/>
            <p:cNvSpPr txBox="1"/>
            <p:nvPr/>
          </p:nvSpPr>
          <p:spPr>
            <a:xfrm rot="16200000">
              <a:off x="8540834" y="3851984"/>
              <a:ext cx="395974" cy="255767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16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34" name="TextBox 42"/>
            <p:cNvSpPr txBox="1"/>
            <p:nvPr/>
          </p:nvSpPr>
          <p:spPr>
            <a:xfrm rot="16200000">
              <a:off x="8550306" y="4175984"/>
              <a:ext cx="377030" cy="255767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/>
            <a:p>
              <a:pPr algn="r" rtl="1">
                <a:spcAft>
                  <a:spcPts val="0"/>
                </a:spcAft>
              </a:pP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20</a:t>
              </a:r>
              <a:endParaRPr lang="en-US" sz="1200" b="1" dirty="0">
                <a:effectLst/>
                <a:latin typeface="Times New Roman"/>
                <a:ea typeface="Times New Roman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-27111" y="0"/>
            <a:ext cx="8781679" cy="5699109"/>
            <a:chOff x="-27111" y="-117663"/>
            <a:chExt cx="8452376" cy="5501356"/>
          </a:xfrm>
        </p:grpSpPr>
        <p:pic>
          <p:nvPicPr>
            <p:cNvPr id="6" name="Picture 5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57" t="282" r="25382" b="58"/>
            <a:stretch/>
          </p:blipFill>
          <p:spPr bwMode="auto">
            <a:xfrm rot="16200000">
              <a:off x="2949059" y="-2942785"/>
              <a:ext cx="2605219" cy="82554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7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63" t="1981" r="4859" b="4738"/>
            <a:stretch/>
          </p:blipFill>
          <p:spPr bwMode="auto">
            <a:xfrm rot="16200000">
              <a:off x="3155349" y="-836001"/>
              <a:ext cx="2087455" cy="84523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2" name="Group 21"/>
            <p:cNvGrpSpPr/>
            <p:nvPr/>
          </p:nvGrpSpPr>
          <p:grpSpPr>
            <a:xfrm>
              <a:off x="137841" y="4505071"/>
              <a:ext cx="8254000" cy="878622"/>
              <a:chOff x="177347" y="4581128"/>
              <a:chExt cx="8134557" cy="848546"/>
            </a:xfrm>
          </p:grpSpPr>
          <p:sp>
            <p:nvSpPr>
              <p:cNvPr id="2" name="Left Brace 1"/>
              <p:cNvSpPr/>
              <p:nvPr/>
            </p:nvSpPr>
            <p:spPr>
              <a:xfrm rot="16200000">
                <a:off x="585750" y="4183140"/>
                <a:ext cx="144016" cy="939993"/>
              </a:xfrm>
              <a:prstGeom prst="leftBrace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6" name="Left Brace 35"/>
              <p:cNvSpPr/>
              <p:nvPr/>
            </p:nvSpPr>
            <p:spPr>
              <a:xfrm rot="16200000">
                <a:off x="1819740" y="3953373"/>
                <a:ext cx="144018" cy="1399529"/>
              </a:xfrm>
              <a:prstGeom prst="leftBrace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7" name="Left Brace 36"/>
              <p:cNvSpPr/>
              <p:nvPr/>
            </p:nvSpPr>
            <p:spPr>
              <a:xfrm rot="16200000">
                <a:off x="3356249" y="3853386"/>
                <a:ext cx="144016" cy="1599501"/>
              </a:xfrm>
              <a:prstGeom prst="leftBrace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8" name="Left Brace 37"/>
              <p:cNvSpPr/>
              <p:nvPr/>
            </p:nvSpPr>
            <p:spPr>
              <a:xfrm rot="16200000">
                <a:off x="4292249" y="4543179"/>
                <a:ext cx="144016" cy="219915"/>
              </a:xfrm>
              <a:prstGeom prst="leftBrace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9" name="Left Brace 38"/>
              <p:cNvSpPr/>
              <p:nvPr/>
            </p:nvSpPr>
            <p:spPr>
              <a:xfrm rot="16200000">
                <a:off x="4508249" y="4581129"/>
                <a:ext cx="144018" cy="144017"/>
              </a:xfrm>
              <a:prstGeom prst="leftBrace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40" name="Left Brace 39"/>
              <p:cNvSpPr/>
              <p:nvPr/>
            </p:nvSpPr>
            <p:spPr>
              <a:xfrm rot="16200000">
                <a:off x="4886266" y="4383089"/>
                <a:ext cx="144018" cy="540097"/>
              </a:xfrm>
              <a:prstGeom prst="leftBrace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41" name="Left Brace 40"/>
              <p:cNvSpPr/>
              <p:nvPr/>
            </p:nvSpPr>
            <p:spPr>
              <a:xfrm rot="16200000">
                <a:off x="5300249" y="4543180"/>
                <a:ext cx="144018" cy="219915"/>
              </a:xfrm>
              <a:prstGeom prst="leftBrace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42" name="Left Brace 41"/>
              <p:cNvSpPr/>
              <p:nvPr/>
            </p:nvSpPr>
            <p:spPr>
              <a:xfrm rot="16200000">
                <a:off x="6848249" y="3261491"/>
                <a:ext cx="144017" cy="2783292"/>
              </a:xfrm>
              <a:prstGeom prst="leftBrace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 rot="20021223">
                <a:off x="177347" y="4721788"/>
                <a:ext cx="899592" cy="70788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000" b="1" dirty="0" smtClean="0"/>
                  <a:t>gene expression </a:t>
                </a:r>
                <a:r>
                  <a:rPr lang="en-US" sz="1000" b="1" dirty="0"/>
                  <a:t>and RNA metabolism</a:t>
                </a:r>
                <a:endParaRPr lang="he-IL" sz="1000" b="1" dirty="0"/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 rot="19451827">
                <a:off x="1253240" y="4755437"/>
                <a:ext cx="899592" cy="400110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000" b="1" dirty="0"/>
                  <a:t>cellular</a:t>
                </a:r>
                <a:r>
                  <a:rPr lang="en-US" sz="1000" dirty="0"/>
                  <a:t> </a:t>
                </a:r>
                <a:r>
                  <a:rPr lang="en-US" sz="1000" b="1" dirty="0"/>
                  <a:t>transport</a:t>
                </a:r>
                <a:endParaRPr lang="he-IL" sz="1000" b="1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 rot="19729464">
                <a:off x="2870997" y="4710058"/>
                <a:ext cx="962670" cy="553998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000" b="1" dirty="0"/>
                  <a:t>signal transduction and hormones</a:t>
                </a:r>
                <a:endParaRPr lang="he-IL" sz="1000" b="1" dirty="0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 rot="19612088">
                <a:off x="3909417" y="4742415"/>
                <a:ext cx="683577" cy="400110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000" b="1" dirty="0"/>
                  <a:t>energy </a:t>
                </a:r>
                <a:r>
                  <a:rPr lang="en-US" sz="1000" b="1" dirty="0" smtClean="0"/>
                  <a:t>reserve</a:t>
                </a:r>
                <a:endParaRPr lang="he-IL" sz="1000" b="1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9413219">
                <a:off x="4368052" y="4761079"/>
                <a:ext cx="998809" cy="553998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000" b="1" dirty="0" smtClean="0"/>
                  <a:t>cell fate</a:t>
                </a:r>
              </a:p>
              <a:p>
                <a:pPr algn="ctr"/>
                <a:r>
                  <a:rPr lang="en-US" sz="1000" b="1" dirty="0" smtClean="0"/>
                  <a:t>and</a:t>
                </a:r>
              </a:p>
              <a:p>
                <a:pPr algn="ctr"/>
                <a:r>
                  <a:rPr lang="en-US" sz="1000" b="1" dirty="0" smtClean="0"/>
                  <a:t>development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 rot="19266183">
                <a:off x="5015753" y="4797960"/>
                <a:ext cx="899592" cy="246221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000" b="1" dirty="0"/>
                  <a:t>stresses</a:t>
                </a:r>
                <a:endParaRPr lang="he-IL" sz="1000" b="1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 rot="19055695">
                <a:off x="6361134" y="4795725"/>
                <a:ext cx="899592" cy="400110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000" b="1" dirty="0" smtClean="0"/>
                  <a:t>biosynthesis related</a:t>
                </a:r>
                <a:r>
                  <a:rPr lang="he-IL" sz="1000" b="1" dirty="0" smtClean="0"/>
                  <a:t> </a:t>
                </a:r>
                <a:endParaRPr lang="he-IL" sz="1000" b="1" dirty="0"/>
              </a:p>
            </p:txBody>
          </p:sp>
        </p:grpSp>
      </p:grpSp>
      <p:sp>
        <p:nvSpPr>
          <p:cNvPr id="50" name="TextBox 49"/>
          <p:cNvSpPr txBox="1"/>
          <p:nvPr/>
        </p:nvSpPr>
        <p:spPr>
          <a:xfrm>
            <a:off x="25104" y="4173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B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157900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0" y="25188"/>
            <a:ext cx="200179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 smtClean="0"/>
              <a:t>Figure S3:</a:t>
            </a:r>
            <a:endParaRPr lang="he-IL" dirty="0"/>
          </a:p>
        </p:txBody>
      </p:sp>
      <p:pic>
        <p:nvPicPr>
          <p:cNvPr id="63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" r="7110"/>
          <a:stretch/>
        </p:blipFill>
        <p:spPr bwMode="auto">
          <a:xfrm>
            <a:off x="108008" y="1469245"/>
            <a:ext cx="9035992" cy="1691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4" name="Rectangle 63"/>
          <p:cNvSpPr/>
          <p:nvPr/>
        </p:nvSpPr>
        <p:spPr>
          <a:xfrm>
            <a:off x="7596336" y="1253711"/>
            <a:ext cx="1547664" cy="22062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6T0087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5T0969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7T1842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10T0542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10T0228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8T1101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3T1970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Un_randomT2044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Un_randomT2042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Un_randomT2043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6T1291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Un_randomT2605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1T1825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Un_randomT26960</a:t>
            </a:r>
          </a:p>
          <a:p>
            <a:pPr algn="l"/>
            <a:r>
              <a:rPr lang="en-US" sz="700" b="1" dirty="0" smtClean="0">
                <a:solidFill>
                  <a:schemeClr val="tx1"/>
                </a:solidFill>
              </a:rPr>
              <a:t>GSMUA_Achr10T16070</a:t>
            </a:r>
            <a:endParaRPr lang="en-US" sz="700" b="1" dirty="0"/>
          </a:p>
        </p:txBody>
      </p:sp>
      <p:sp>
        <p:nvSpPr>
          <p:cNvPr id="65" name="TextBox 64"/>
          <p:cNvSpPr txBox="1"/>
          <p:nvPr/>
        </p:nvSpPr>
        <p:spPr>
          <a:xfrm rot="18000000">
            <a:off x="3260" y="1189204"/>
            <a:ext cx="651140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PB/MG</a:t>
            </a:r>
            <a:endParaRPr lang="he-IL" sz="1200" b="1" dirty="0"/>
          </a:p>
        </p:txBody>
      </p:sp>
      <p:sp>
        <p:nvSpPr>
          <p:cNvPr id="66" name="TextBox 65"/>
          <p:cNvSpPr txBox="1"/>
          <p:nvPr/>
        </p:nvSpPr>
        <p:spPr>
          <a:xfrm rot="18000000">
            <a:off x="465366" y="1230081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B/MG</a:t>
            </a:r>
            <a:endParaRPr lang="he-IL" sz="1200" b="1" dirty="0"/>
          </a:p>
        </p:txBody>
      </p:sp>
      <p:sp>
        <p:nvSpPr>
          <p:cNvPr id="67" name="TextBox 66"/>
          <p:cNvSpPr txBox="1"/>
          <p:nvPr/>
        </p:nvSpPr>
        <p:spPr>
          <a:xfrm rot="18000000">
            <a:off x="836438" y="1232768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R/MG</a:t>
            </a:r>
            <a:endParaRPr lang="he-IL" sz="1200" b="1" dirty="0"/>
          </a:p>
        </p:txBody>
      </p:sp>
      <p:sp>
        <p:nvSpPr>
          <p:cNvPr id="68" name="TextBox 67"/>
          <p:cNvSpPr txBox="1"/>
          <p:nvPr/>
        </p:nvSpPr>
        <p:spPr>
          <a:xfrm rot="18000000">
            <a:off x="1216579" y="1201637"/>
            <a:ext cx="651140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PB/MG</a:t>
            </a:r>
            <a:endParaRPr lang="he-IL" sz="1200" b="1" dirty="0"/>
          </a:p>
        </p:txBody>
      </p:sp>
      <p:sp>
        <p:nvSpPr>
          <p:cNvPr id="69" name="TextBox 68"/>
          <p:cNvSpPr txBox="1"/>
          <p:nvPr/>
        </p:nvSpPr>
        <p:spPr>
          <a:xfrm rot="18000000">
            <a:off x="1689502" y="1242514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B/MG</a:t>
            </a:r>
            <a:endParaRPr lang="he-IL" sz="1200" b="1" dirty="0"/>
          </a:p>
        </p:txBody>
      </p:sp>
      <p:sp>
        <p:nvSpPr>
          <p:cNvPr id="70" name="TextBox 69"/>
          <p:cNvSpPr txBox="1"/>
          <p:nvPr/>
        </p:nvSpPr>
        <p:spPr>
          <a:xfrm rot="18000000">
            <a:off x="2132582" y="1245201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R/MG</a:t>
            </a:r>
            <a:endParaRPr lang="he-IL" sz="1200" b="1" dirty="0"/>
          </a:p>
        </p:txBody>
      </p:sp>
      <p:sp>
        <p:nvSpPr>
          <p:cNvPr id="71" name="TextBox 70"/>
          <p:cNvSpPr txBox="1"/>
          <p:nvPr/>
        </p:nvSpPr>
        <p:spPr>
          <a:xfrm rot="18000000">
            <a:off x="2512723" y="1201637"/>
            <a:ext cx="651140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PB/MG</a:t>
            </a:r>
            <a:endParaRPr lang="he-IL" sz="1200" b="1" dirty="0"/>
          </a:p>
        </p:txBody>
      </p:sp>
      <p:sp>
        <p:nvSpPr>
          <p:cNvPr id="72" name="TextBox 71"/>
          <p:cNvSpPr txBox="1"/>
          <p:nvPr/>
        </p:nvSpPr>
        <p:spPr>
          <a:xfrm rot="18000000">
            <a:off x="2985646" y="1242514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B/MG</a:t>
            </a:r>
            <a:endParaRPr lang="he-IL" sz="1200" b="1" dirty="0"/>
          </a:p>
        </p:txBody>
      </p:sp>
      <p:sp>
        <p:nvSpPr>
          <p:cNvPr id="73" name="TextBox 72"/>
          <p:cNvSpPr txBox="1"/>
          <p:nvPr/>
        </p:nvSpPr>
        <p:spPr>
          <a:xfrm rot="18000000">
            <a:off x="3356718" y="1245201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R/MG</a:t>
            </a:r>
            <a:endParaRPr lang="he-IL" sz="1200" b="1" dirty="0"/>
          </a:p>
        </p:txBody>
      </p:sp>
      <p:sp>
        <p:nvSpPr>
          <p:cNvPr id="74" name="TextBox 73"/>
          <p:cNvSpPr txBox="1"/>
          <p:nvPr/>
        </p:nvSpPr>
        <p:spPr>
          <a:xfrm rot="18000000">
            <a:off x="3736859" y="1201637"/>
            <a:ext cx="651140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PB/MG</a:t>
            </a:r>
            <a:endParaRPr lang="he-IL" sz="1200" b="1" dirty="0"/>
          </a:p>
        </p:txBody>
      </p:sp>
      <p:sp>
        <p:nvSpPr>
          <p:cNvPr id="75" name="TextBox 74"/>
          <p:cNvSpPr txBox="1"/>
          <p:nvPr/>
        </p:nvSpPr>
        <p:spPr>
          <a:xfrm rot="18000000">
            <a:off x="4209782" y="1242514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B/MG</a:t>
            </a:r>
            <a:endParaRPr lang="he-IL" sz="1200" b="1" dirty="0"/>
          </a:p>
        </p:txBody>
      </p:sp>
      <p:sp>
        <p:nvSpPr>
          <p:cNvPr id="76" name="TextBox 75"/>
          <p:cNvSpPr txBox="1"/>
          <p:nvPr/>
        </p:nvSpPr>
        <p:spPr>
          <a:xfrm rot="18000000">
            <a:off x="4652862" y="1245201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R/MG</a:t>
            </a:r>
            <a:endParaRPr lang="he-IL" sz="1200" b="1" dirty="0"/>
          </a:p>
        </p:txBody>
      </p:sp>
      <p:sp>
        <p:nvSpPr>
          <p:cNvPr id="77" name="TextBox 76"/>
          <p:cNvSpPr txBox="1"/>
          <p:nvPr/>
        </p:nvSpPr>
        <p:spPr>
          <a:xfrm rot="18000000">
            <a:off x="4960995" y="1201637"/>
            <a:ext cx="651140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PB/MG</a:t>
            </a:r>
            <a:endParaRPr lang="he-IL" sz="1200" b="1" dirty="0"/>
          </a:p>
        </p:txBody>
      </p:sp>
      <p:sp>
        <p:nvSpPr>
          <p:cNvPr id="78" name="TextBox 77"/>
          <p:cNvSpPr txBox="1"/>
          <p:nvPr/>
        </p:nvSpPr>
        <p:spPr>
          <a:xfrm rot="18000000">
            <a:off x="5433918" y="1242514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B/MG</a:t>
            </a:r>
            <a:endParaRPr lang="he-IL" sz="1200" b="1" dirty="0"/>
          </a:p>
        </p:txBody>
      </p:sp>
      <p:sp>
        <p:nvSpPr>
          <p:cNvPr id="79" name="TextBox 78"/>
          <p:cNvSpPr txBox="1"/>
          <p:nvPr/>
        </p:nvSpPr>
        <p:spPr>
          <a:xfrm rot="18000000">
            <a:off x="5876998" y="1245201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R/MG</a:t>
            </a:r>
            <a:endParaRPr lang="he-IL" sz="1200" b="1" dirty="0"/>
          </a:p>
        </p:txBody>
      </p:sp>
      <p:sp>
        <p:nvSpPr>
          <p:cNvPr id="80" name="TextBox 79"/>
          <p:cNvSpPr txBox="1"/>
          <p:nvPr/>
        </p:nvSpPr>
        <p:spPr>
          <a:xfrm rot="18000000">
            <a:off x="6257139" y="1201637"/>
            <a:ext cx="651140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PB/MG</a:t>
            </a:r>
            <a:endParaRPr lang="he-IL" sz="1200" b="1" dirty="0"/>
          </a:p>
        </p:txBody>
      </p:sp>
      <p:sp>
        <p:nvSpPr>
          <p:cNvPr id="81" name="TextBox 80"/>
          <p:cNvSpPr txBox="1"/>
          <p:nvPr/>
        </p:nvSpPr>
        <p:spPr>
          <a:xfrm rot="18000000">
            <a:off x="6730062" y="1242514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B/MG</a:t>
            </a:r>
            <a:endParaRPr lang="he-IL" sz="1200" b="1" dirty="0"/>
          </a:p>
        </p:txBody>
      </p:sp>
      <p:sp>
        <p:nvSpPr>
          <p:cNvPr id="82" name="TextBox 81"/>
          <p:cNvSpPr txBox="1"/>
          <p:nvPr/>
        </p:nvSpPr>
        <p:spPr>
          <a:xfrm rot="18000000">
            <a:off x="7173142" y="1245201"/>
            <a:ext cx="56938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b="1" dirty="0" smtClean="0"/>
              <a:t>R/MG</a:t>
            </a:r>
            <a:endParaRPr lang="he-IL" sz="1200" b="1" dirty="0"/>
          </a:p>
        </p:txBody>
      </p:sp>
      <p:sp>
        <p:nvSpPr>
          <p:cNvPr id="83" name="TextBox 82"/>
          <p:cNvSpPr txBox="1"/>
          <p:nvPr/>
        </p:nvSpPr>
        <p:spPr>
          <a:xfrm>
            <a:off x="318012" y="805935"/>
            <a:ext cx="869612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 smtClean="0"/>
              <a:t>Pulp</a:t>
            </a:r>
            <a:endParaRPr lang="he-IL" sz="1600" b="1" dirty="0"/>
          </a:p>
        </p:txBody>
      </p:sp>
      <p:sp>
        <p:nvSpPr>
          <p:cNvPr id="84" name="TextBox 83"/>
          <p:cNvSpPr txBox="1"/>
          <p:nvPr/>
        </p:nvSpPr>
        <p:spPr>
          <a:xfrm>
            <a:off x="1547664" y="805935"/>
            <a:ext cx="869612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 smtClean="0"/>
              <a:t>Peel</a:t>
            </a:r>
            <a:endParaRPr lang="he-IL" sz="1600" b="1" dirty="0"/>
          </a:p>
        </p:txBody>
      </p:sp>
      <p:sp>
        <p:nvSpPr>
          <p:cNvPr id="85" name="TextBox 84"/>
          <p:cNvSpPr txBox="1"/>
          <p:nvPr/>
        </p:nvSpPr>
        <p:spPr>
          <a:xfrm>
            <a:off x="2832776" y="805935"/>
            <a:ext cx="869612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 smtClean="0"/>
              <a:t>Pulp</a:t>
            </a:r>
            <a:endParaRPr lang="he-IL" sz="1600" b="1" dirty="0"/>
          </a:p>
        </p:txBody>
      </p:sp>
      <p:sp>
        <p:nvSpPr>
          <p:cNvPr id="86" name="TextBox 85"/>
          <p:cNvSpPr txBox="1"/>
          <p:nvPr/>
        </p:nvSpPr>
        <p:spPr>
          <a:xfrm>
            <a:off x="4062428" y="805935"/>
            <a:ext cx="869612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 smtClean="0"/>
              <a:t>Peel</a:t>
            </a:r>
            <a:endParaRPr lang="he-IL" sz="1600" b="1" dirty="0"/>
          </a:p>
        </p:txBody>
      </p:sp>
      <p:sp>
        <p:nvSpPr>
          <p:cNvPr id="87" name="TextBox 86"/>
          <p:cNvSpPr txBox="1"/>
          <p:nvPr/>
        </p:nvSpPr>
        <p:spPr>
          <a:xfrm>
            <a:off x="5292080" y="805935"/>
            <a:ext cx="869612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 smtClean="0"/>
              <a:t>Pulp</a:t>
            </a:r>
            <a:endParaRPr lang="he-IL" sz="1600" b="1" dirty="0"/>
          </a:p>
        </p:txBody>
      </p:sp>
      <p:sp>
        <p:nvSpPr>
          <p:cNvPr id="88" name="TextBox 87"/>
          <p:cNvSpPr txBox="1"/>
          <p:nvPr/>
        </p:nvSpPr>
        <p:spPr>
          <a:xfrm>
            <a:off x="6582708" y="805935"/>
            <a:ext cx="869612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 smtClean="0"/>
              <a:t>Peel</a:t>
            </a:r>
            <a:endParaRPr lang="he-IL" sz="1600" b="1" dirty="0"/>
          </a:p>
        </p:txBody>
      </p:sp>
      <p:sp>
        <p:nvSpPr>
          <p:cNvPr id="89" name="TextBox 88"/>
          <p:cNvSpPr txBox="1"/>
          <p:nvPr/>
        </p:nvSpPr>
        <p:spPr>
          <a:xfrm>
            <a:off x="467544" y="496417"/>
            <a:ext cx="1760130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 smtClean="0"/>
              <a:t>WT</a:t>
            </a:r>
            <a:endParaRPr lang="he-IL" sz="1600" b="1" dirty="0"/>
          </a:p>
        </p:txBody>
      </p:sp>
      <p:sp>
        <p:nvSpPr>
          <p:cNvPr id="90" name="TextBox 89"/>
          <p:cNvSpPr txBox="1"/>
          <p:nvPr/>
        </p:nvSpPr>
        <p:spPr>
          <a:xfrm>
            <a:off x="2955886" y="496417"/>
            <a:ext cx="1760130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 smtClean="0"/>
              <a:t>32</a:t>
            </a:r>
            <a:endParaRPr lang="he-IL" sz="1600" b="1" dirty="0"/>
          </a:p>
        </p:txBody>
      </p:sp>
      <p:sp>
        <p:nvSpPr>
          <p:cNvPr id="91" name="TextBox 90"/>
          <p:cNvSpPr txBox="1"/>
          <p:nvPr/>
        </p:nvSpPr>
        <p:spPr>
          <a:xfrm>
            <a:off x="5508104" y="496417"/>
            <a:ext cx="1760130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 smtClean="0"/>
              <a:t>44</a:t>
            </a:r>
            <a:endParaRPr lang="he-IL" sz="1600" b="1" dirty="0"/>
          </a:p>
        </p:txBody>
      </p:sp>
      <p:pic>
        <p:nvPicPr>
          <p:cNvPr id="9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29200" y="3255516"/>
            <a:ext cx="2474913" cy="31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" name="Straight Connector 2"/>
          <p:cNvCxnSpPr/>
          <p:nvPr/>
        </p:nvCxnSpPr>
        <p:spPr>
          <a:xfrm flipV="1">
            <a:off x="2610000" y="504000"/>
            <a:ext cx="0" cy="10603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V="1">
            <a:off x="5112000" y="504000"/>
            <a:ext cx="0" cy="10603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flipV="1">
            <a:off x="1368000" y="836792"/>
            <a:ext cx="0" cy="72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V="1">
            <a:off x="3862800" y="835200"/>
            <a:ext cx="0" cy="72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V="1">
            <a:off x="6372200" y="835200"/>
            <a:ext cx="0" cy="72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95351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35496" y="199673"/>
            <a:ext cx="8233792" cy="2581255"/>
            <a:chOff x="35496" y="199673"/>
            <a:chExt cx="8233792" cy="2581255"/>
          </a:xfrm>
        </p:grpSpPr>
        <p:pic>
          <p:nvPicPr>
            <p:cNvPr id="2" name="Picture 5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b="13612"/>
            <a:stretch/>
          </p:blipFill>
          <p:spPr bwMode="auto">
            <a:xfrm>
              <a:off x="144463" y="1159763"/>
              <a:ext cx="8124825" cy="1036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785905" y="591651"/>
              <a:ext cx="543740" cy="4001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000" b="1" dirty="0" smtClean="0"/>
                <a:t>WT</a:t>
              </a:r>
              <a:endParaRPr lang="he-IL" sz="2000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701717" y="591651"/>
              <a:ext cx="444352" cy="4001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000" b="1" dirty="0" smtClean="0"/>
                <a:t>44</a:t>
              </a:r>
              <a:endParaRPr lang="he-IL" sz="20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831504" y="591651"/>
              <a:ext cx="444352" cy="4001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000" b="1" dirty="0" smtClean="0"/>
                <a:t>32</a:t>
              </a:r>
              <a:endParaRPr lang="he-IL" sz="20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55858" y="910461"/>
              <a:ext cx="52771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MG</a:t>
              </a:r>
              <a:endParaRPr lang="he-IL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48000" y="910461"/>
              <a:ext cx="42832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PB</a:t>
              </a:r>
              <a:endParaRPr lang="he-IL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206861" y="910461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B</a:t>
              </a:r>
              <a:endParaRPr lang="he-IL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70012" y="910461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R</a:t>
              </a:r>
              <a:endParaRPr lang="he-IL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028066" y="910461"/>
              <a:ext cx="52771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MG</a:t>
              </a:r>
              <a:endParaRPr lang="he-IL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555728" y="910461"/>
              <a:ext cx="42832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PB</a:t>
              </a:r>
              <a:endParaRPr lang="he-IL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114589" y="910461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B</a:t>
              </a:r>
              <a:endParaRPr lang="he-IL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577740" y="910461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R</a:t>
              </a:r>
              <a:endParaRPr lang="he-IL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972282" y="910461"/>
              <a:ext cx="52771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MG</a:t>
              </a:r>
              <a:endParaRPr lang="he-IL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464424" y="910461"/>
              <a:ext cx="42832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PB</a:t>
              </a:r>
              <a:endParaRPr lang="he-IL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023285" y="910461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B</a:t>
              </a:r>
              <a:endParaRPr lang="he-IL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486436" y="910461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R</a:t>
              </a:r>
              <a:endParaRPr lang="he-IL" dirty="0"/>
            </a:p>
          </p:txBody>
        </p:sp>
        <p:cxnSp>
          <p:nvCxnSpPr>
            <p:cNvPr id="18" name="Straight Connector 17"/>
            <p:cNvCxnSpPr/>
            <p:nvPr/>
          </p:nvCxnSpPr>
          <p:spPr>
            <a:xfrm flipV="1">
              <a:off x="2070000" y="631785"/>
              <a:ext cx="0" cy="576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V="1">
              <a:off x="3978000" y="627191"/>
              <a:ext cx="0" cy="576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1259632" y="199673"/>
              <a:ext cx="3470236" cy="461665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2400" b="1" dirty="0" smtClean="0"/>
                <a:t>CRE1</a:t>
              </a:r>
              <a:endParaRPr lang="he-IL" sz="2400" b="1" dirty="0"/>
            </a:p>
          </p:txBody>
        </p:sp>
        <p:pic>
          <p:nvPicPr>
            <p:cNvPr id="21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000" y="2522513"/>
              <a:ext cx="1895475" cy="603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>
              <a:off x="35496" y="2503929"/>
              <a:ext cx="263213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200" dirty="0" smtClean="0"/>
                <a:t>0</a:t>
              </a:r>
              <a:endParaRPr lang="he-IL" sz="12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775428" y="2503929"/>
              <a:ext cx="420308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200" dirty="0" smtClean="0"/>
                <a:t>105</a:t>
              </a:r>
              <a:endParaRPr lang="he-IL" sz="1200" dirty="0"/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0" y="25188"/>
            <a:ext cx="200179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 smtClean="0"/>
              <a:t>Figure S4: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0076543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323528" y="548680"/>
            <a:ext cx="8281417" cy="2828636"/>
            <a:chOff x="35496" y="2688596"/>
            <a:chExt cx="8281417" cy="2828636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4463" y="3645024"/>
              <a:ext cx="8172450" cy="14573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785905" y="3038183"/>
              <a:ext cx="543740" cy="4001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000" b="1" dirty="0" smtClean="0"/>
                <a:t>WT</a:t>
              </a:r>
              <a:endParaRPr lang="he-IL" sz="2000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701717" y="3038183"/>
              <a:ext cx="444352" cy="4001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000" b="1" dirty="0" smtClean="0"/>
                <a:t>44</a:t>
              </a:r>
              <a:endParaRPr lang="he-IL" sz="20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831504" y="3038183"/>
              <a:ext cx="444352" cy="4001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000" b="1" dirty="0" smtClean="0"/>
                <a:t>32</a:t>
              </a:r>
              <a:endParaRPr lang="he-IL" sz="20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07504" y="3356993"/>
              <a:ext cx="52771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MG</a:t>
              </a:r>
              <a:endParaRPr lang="he-IL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48000" y="3356993"/>
              <a:ext cx="42832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PB</a:t>
              </a:r>
              <a:endParaRPr lang="he-IL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206861" y="3356993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B</a:t>
              </a:r>
              <a:endParaRPr lang="he-IL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70012" y="3356993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R</a:t>
              </a:r>
              <a:endParaRPr lang="he-IL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028066" y="3356993"/>
              <a:ext cx="52771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MG</a:t>
              </a:r>
              <a:endParaRPr lang="he-IL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555728" y="3356993"/>
              <a:ext cx="42832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PB</a:t>
              </a:r>
              <a:endParaRPr lang="he-IL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114589" y="3356993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B</a:t>
              </a:r>
              <a:endParaRPr lang="he-IL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577740" y="3356993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R</a:t>
              </a:r>
              <a:endParaRPr lang="he-IL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923928" y="3356993"/>
              <a:ext cx="52771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MG</a:t>
              </a:r>
              <a:endParaRPr lang="he-IL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464424" y="3356993"/>
              <a:ext cx="42832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PB</a:t>
              </a:r>
              <a:endParaRPr lang="he-IL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023285" y="3356993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B</a:t>
              </a:r>
              <a:endParaRPr lang="he-IL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486436" y="3356993"/>
              <a:ext cx="30970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R</a:t>
              </a:r>
              <a:endParaRPr lang="he-IL" dirty="0"/>
            </a:p>
          </p:txBody>
        </p:sp>
        <p:cxnSp>
          <p:nvCxnSpPr>
            <p:cNvPr id="18" name="Straight Connector 17"/>
            <p:cNvCxnSpPr/>
            <p:nvPr/>
          </p:nvCxnSpPr>
          <p:spPr>
            <a:xfrm flipV="1">
              <a:off x="2070000" y="3069024"/>
              <a:ext cx="0" cy="576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V="1">
              <a:off x="3978000" y="3064430"/>
              <a:ext cx="0" cy="576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2325900" y="2688596"/>
              <a:ext cx="1454012" cy="461665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2400" b="1" dirty="0" smtClean="0"/>
                <a:t>TIR</a:t>
              </a:r>
              <a:endParaRPr lang="he-IL" sz="2400" b="1" dirty="0"/>
            </a:p>
          </p:txBody>
        </p:sp>
        <p:pic>
          <p:nvPicPr>
            <p:cNvPr id="21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000" y="5229200"/>
              <a:ext cx="1895475" cy="603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>
              <a:off x="35496" y="5240233"/>
              <a:ext cx="263213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200" dirty="0" smtClean="0"/>
                <a:t>0</a:t>
              </a:r>
              <a:endParaRPr lang="he-IL" sz="12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853976" y="5240233"/>
              <a:ext cx="341760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200" dirty="0" smtClean="0"/>
                <a:t>60</a:t>
              </a:r>
              <a:endParaRPr lang="he-IL" sz="1200" dirty="0"/>
            </a:p>
          </p:txBody>
        </p:sp>
      </p:grpSp>
      <p:sp>
        <p:nvSpPr>
          <p:cNvPr id="42" name="TextBox 41"/>
          <p:cNvSpPr txBox="1"/>
          <p:nvPr/>
        </p:nvSpPr>
        <p:spPr>
          <a:xfrm>
            <a:off x="0" y="25188"/>
            <a:ext cx="200179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 smtClean="0"/>
              <a:t>Figure S5: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3263230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TextBox 94"/>
          <p:cNvSpPr txBox="1"/>
          <p:nvPr/>
        </p:nvSpPr>
        <p:spPr>
          <a:xfrm>
            <a:off x="-22085" y="-27384"/>
            <a:ext cx="120970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 smtClean="0"/>
              <a:t>Figure S6:</a:t>
            </a:r>
            <a:endParaRPr lang="he-IL" dirty="0"/>
          </a:p>
        </p:txBody>
      </p:sp>
      <p:grpSp>
        <p:nvGrpSpPr>
          <p:cNvPr id="19" name="Group 18"/>
          <p:cNvGrpSpPr/>
          <p:nvPr/>
        </p:nvGrpSpPr>
        <p:grpSpPr>
          <a:xfrm>
            <a:off x="251520" y="673495"/>
            <a:ext cx="8726219" cy="1675385"/>
            <a:chOff x="186259" y="4849959"/>
            <a:chExt cx="8726219" cy="1675385"/>
          </a:xfrm>
        </p:grpSpPr>
        <p:grpSp>
          <p:nvGrpSpPr>
            <p:cNvPr id="129" name="Group 128"/>
            <p:cNvGrpSpPr>
              <a:grpSpLocks/>
            </p:cNvGrpSpPr>
            <p:nvPr/>
          </p:nvGrpSpPr>
          <p:grpSpPr>
            <a:xfrm>
              <a:off x="186259" y="4869159"/>
              <a:ext cx="5763441" cy="1656184"/>
              <a:chOff x="186258" y="4838229"/>
              <a:chExt cx="7986142" cy="1903139"/>
            </a:xfrm>
          </p:grpSpPr>
          <p:pic>
            <p:nvPicPr>
              <p:cNvPr id="130" name="Picture 4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5225" y="5881737"/>
                <a:ext cx="7877175" cy="4572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1" name="TextBox 130"/>
              <p:cNvSpPr txBox="1"/>
              <p:nvPr/>
            </p:nvSpPr>
            <p:spPr>
              <a:xfrm>
                <a:off x="1039414" y="5169210"/>
                <a:ext cx="543739" cy="4001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2000" b="1" dirty="0" smtClean="0"/>
                  <a:t>WT</a:t>
                </a:r>
                <a:endParaRPr lang="he-IL" sz="2000" b="1" dirty="0"/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4852480" y="5169210"/>
                <a:ext cx="444352" cy="4001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2000" b="1" dirty="0" smtClean="0"/>
                  <a:t>44</a:t>
                </a:r>
                <a:endParaRPr lang="he-IL" sz="2000" b="1" dirty="0"/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2982266" y="5169210"/>
                <a:ext cx="444352" cy="4001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2000" b="1" dirty="0" smtClean="0"/>
                  <a:t>32</a:t>
                </a:r>
                <a:endParaRPr lang="he-IL" sz="2000" b="1" dirty="0"/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784928" y="5609565"/>
                <a:ext cx="557969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PB</a:t>
                </a:r>
                <a:endParaRPr lang="he-IL" sz="1600" dirty="0"/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1371341" y="5609565"/>
                <a:ext cx="411369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B</a:t>
                </a:r>
                <a:endParaRPr lang="he-IL" sz="1600" dirty="0"/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1770454" y="5609565"/>
                <a:ext cx="411369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R</a:t>
                </a:r>
                <a:endParaRPr lang="he-IL" sz="1600" dirty="0"/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>
                <a:off x="2621637" y="5609565"/>
                <a:ext cx="557969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PB</a:t>
                </a:r>
                <a:endParaRPr lang="he-IL" sz="1600" dirty="0"/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>
                <a:off x="3229822" y="5609565"/>
                <a:ext cx="411369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B</a:t>
                </a:r>
                <a:endParaRPr lang="he-IL" sz="1600" dirty="0"/>
              </a:p>
            </p:txBody>
          </p:sp>
          <p:sp>
            <p:nvSpPr>
              <p:cNvPr id="139" name="TextBox 138"/>
              <p:cNvSpPr txBox="1"/>
              <p:nvPr/>
            </p:nvSpPr>
            <p:spPr>
              <a:xfrm>
                <a:off x="3666241" y="5609565"/>
                <a:ext cx="411369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R</a:t>
                </a:r>
                <a:endParaRPr lang="he-IL" sz="1600" dirty="0"/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4526795" y="5609565"/>
                <a:ext cx="557969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PB</a:t>
                </a:r>
                <a:endParaRPr lang="he-IL" sz="1600" dirty="0"/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5125398" y="5609565"/>
                <a:ext cx="411369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B</a:t>
                </a:r>
                <a:endParaRPr lang="he-IL" sz="1600" dirty="0"/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5574351" y="5609565"/>
                <a:ext cx="411369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R</a:t>
                </a:r>
                <a:endParaRPr lang="he-IL" sz="1600" dirty="0"/>
              </a:p>
            </p:txBody>
          </p:sp>
          <p:cxnSp>
            <p:nvCxnSpPr>
              <p:cNvPr id="143" name="Straight Connector 142"/>
              <p:cNvCxnSpPr/>
              <p:nvPr/>
            </p:nvCxnSpPr>
            <p:spPr>
              <a:xfrm flipV="1">
                <a:off x="2220762" y="5321596"/>
                <a:ext cx="0" cy="576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/>
              <p:cNvCxnSpPr/>
              <p:nvPr/>
            </p:nvCxnSpPr>
            <p:spPr>
              <a:xfrm flipV="1">
                <a:off x="4128762" y="5317002"/>
                <a:ext cx="0" cy="576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TextBox 144"/>
              <p:cNvSpPr txBox="1"/>
              <p:nvPr/>
            </p:nvSpPr>
            <p:spPr>
              <a:xfrm>
                <a:off x="2476662" y="4838229"/>
                <a:ext cx="1454012" cy="46166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2000" b="1" dirty="0" smtClean="0"/>
                  <a:t>DELLA</a:t>
                </a:r>
                <a:endParaRPr lang="he-IL" sz="2000" b="1" dirty="0"/>
              </a:p>
            </p:txBody>
          </p:sp>
          <p:pic>
            <p:nvPicPr>
              <p:cNvPr id="146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2762" y="6482953"/>
                <a:ext cx="1895475" cy="603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47" name="TextBox 146"/>
              <p:cNvSpPr txBox="1"/>
              <p:nvPr/>
            </p:nvSpPr>
            <p:spPr>
              <a:xfrm>
                <a:off x="186258" y="6464369"/>
                <a:ext cx="263213" cy="276999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200" dirty="0" smtClean="0"/>
                  <a:t>0</a:t>
                </a:r>
                <a:endParaRPr lang="he-IL" sz="1200" dirty="0"/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>
                <a:off x="1926190" y="6464369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200" dirty="0" smtClean="0"/>
                  <a:t>265</a:t>
                </a:r>
                <a:endParaRPr lang="he-IL" sz="1200" dirty="0"/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197444" y="5609185"/>
                <a:ext cx="677912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MG</a:t>
                </a:r>
                <a:endParaRPr lang="he-IL" sz="1600" dirty="0"/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2102580" y="5609185"/>
                <a:ext cx="677912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MG</a:t>
                </a:r>
                <a:endParaRPr lang="he-IL" sz="1600" dirty="0"/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>
                <a:off x="4027959" y="5609185"/>
                <a:ext cx="677912" cy="38903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600" dirty="0" smtClean="0"/>
                  <a:t>MG</a:t>
                </a:r>
                <a:endParaRPr lang="he-IL" sz="1600" dirty="0"/>
              </a:p>
            </p:txBody>
          </p:sp>
        </p:grpSp>
        <p:graphicFrame>
          <p:nvGraphicFramePr>
            <p:cNvPr id="153" name="Chart 15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65843269"/>
                </p:ext>
              </p:extLst>
            </p:nvPr>
          </p:nvGraphicFramePr>
          <p:xfrm>
            <a:off x="6044349" y="4850847"/>
            <a:ext cx="2810356" cy="16744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54" name="TextBox 153"/>
            <p:cNvSpPr txBox="1"/>
            <p:nvPr/>
          </p:nvSpPr>
          <p:spPr>
            <a:xfrm rot="16200000">
              <a:off x="5947303" y="5438991"/>
              <a:ext cx="883062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200" b="1" dirty="0" smtClean="0"/>
                <a:t>GA9 (</a:t>
              </a:r>
              <a:r>
                <a:rPr lang="en-US" sz="1200" b="1" dirty="0" err="1" smtClean="0"/>
                <a:t>ng</a:t>
              </a:r>
              <a:r>
                <a:rPr lang="en-US" sz="1200" b="1" dirty="0" smtClean="0"/>
                <a:t>/g)</a:t>
              </a:r>
              <a:endParaRPr lang="he-IL" sz="1200" b="1" dirty="0"/>
            </a:p>
          </p:txBody>
        </p:sp>
        <p:pic>
          <p:nvPicPr>
            <p:cNvPr id="155" name="Picture 2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475" t="1" r="8022" b="65773"/>
            <a:stretch/>
          </p:blipFill>
          <p:spPr bwMode="auto">
            <a:xfrm>
              <a:off x="8565975" y="4849959"/>
              <a:ext cx="346503" cy="6130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2" name="TextBox 1"/>
          <p:cNvSpPr txBox="1"/>
          <p:nvPr/>
        </p:nvSpPr>
        <p:spPr>
          <a:xfrm>
            <a:off x="221836" y="476672"/>
            <a:ext cx="31771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A</a:t>
            </a:r>
            <a:endParaRPr lang="he-IL" dirty="0"/>
          </a:p>
        </p:txBody>
      </p:sp>
      <p:sp>
        <p:nvSpPr>
          <p:cNvPr id="32" name="TextBox 31"/>
          <p:cNvSpPr txBox="1"/>
          <p:nvPr/>
        </p:nvSpPr>
        <p:spPr>
          <a:xfrm>
            <a:off x="6084168" y="476672"/>
            <a:ext cx="31771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B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1621589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496" y="42431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able S1</a:t>
            </a:r>
            <a:endParaRPr lang="en-GB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1344147"/>
              </p:ext>
            </p:extLst>
          </p:nvPr>
        </p:nvGraphicFramePr>
        <p:xfrm>
          <a:off x="1115616" y="371141"/>
          <a:ext cx="6984776" cy="6370227"/>
        </p:xfrm>
        <a:graphic>
          <a:graphicData uri="http://schemas.openxmlformats.org/drawingml/2006/table">
            <a:tbl>
              <a:tblPr firstRow="1" firstCol="1" bandRow="1"/>
              <a:tblGrid>
                <a:gridCol w="1894583"/>
                <a:gridCol w="1489793"/>
                <a:gridCol w="2088232"/>
                <a:gridCol w="1512168"/>
              </a:tblGrid>
              <a:tr h="1717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DH Pahang v1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DH Pahang v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DH Pahang v1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DH Pahang v2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0228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0_g024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6T129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143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054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0_g011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6T165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180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104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2_g027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6T205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218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120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0_g122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6T2557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273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160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0_g161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6T369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38940</a:t>
                      </a:r>
                      <a:endParaRPr lang="en-US" sz="10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196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0_g196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7T036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7_g037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216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0_g215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7T072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7_g072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259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0_g259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7T112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7_g110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280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0_g280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7T184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7_g197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0T304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0_g303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057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055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1T092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1_g088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059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057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1T209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1_g193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068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066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1T242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1_g225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076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074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T178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1_g110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110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107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T182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1_g115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182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177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1T213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1_g146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191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150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2T067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2_g087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199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211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3T017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3_g016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229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236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3T034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3_g032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8T308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312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3T067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3_g066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9T011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9_g010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3T197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3_g205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9T143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9_g138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3T238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3_g251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9T165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9_g158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3T249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3_g261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9T177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9_g163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4T013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4_g012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9T226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9_g231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4T105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4_g105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9T255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9_g260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4T156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4_g156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9T271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9_g277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4T159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4_g162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084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11_g136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4T228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4_g294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087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8_g1668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4T291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4_g356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100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1_g210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4T332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4_g397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107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5_g180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5T025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5_g025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204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144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5T055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5_g052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204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1441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5T081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5_g078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204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144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5T082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5_g079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2084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7_g205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5T096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5_g093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250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4_g376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5T269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5_g2932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2605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1439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6T0087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026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Un_randomT2696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144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1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GSMUA_Achr6T0800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a06_g09630</a:t>
                      </a:r>
                      <a:endParaRPr lang="en-US" sz="10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3918" marR="439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/>
                        <a:cs typeface="Arial"/>
                      </a:endParaRPr>
                    </a:p>
                  </a:txBody>
                  <a:tcPr marL="43918" marR="4391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 dirty="0">
                        <a:effectLst/>
                        <a:latin typeface="Calibri"/>
                        <a:cs typeface="Arial"/>
                      </a:endParaRPr>
                    </a:p>
                  </a:txBody>
                  <a:tcPr marL="43918" marR="43918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451086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60</TotalTime>
  <Words>388</Words>
  <Application>Microsoft Office PowerPoint</Application>
  <PresentationFormat>On-screen Show (4:3)</PresentationFormat>
  <Paragraphs>316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o</dc:creator>
  <cp:lastModifiedBy>Haya Friedman</cp:lastModifiedBy>
  <cp:revision>146</cp:revision>
  <cp:lastPrinted>2018-07-08T15:01:09Z</cp:lastPrinted>
  <dcterms:created xsi:type="dcterms:W3CDTF">2014-07-15T11:15:28Z</dcterms:created>
  <dcterms:modified xsi:type="dcterms:W3CDTF">2018-07-31T17:01:47Z</dcterms:modified>
</cp:coreProperties>
</file>